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DCD78FA-CBF4-4FF6-A4AD-97522FAC536D}" v="17" dt="2026-01-13T15:57:01.08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72" autoAdjust="0"/>
    <p:restoredTop sz="94660"/>
  </p:normalViewPr>
  <p:slideViewPr>
    <p:cSldViewPr snapToGrid="0">
      <p:cViewPr varScale="1">
        <p:scale>
          <a:sx n="87" d="100"/>
          <a:sy n="87" d="100"/>
        </p:scale>
        <p:origin x="298" y="29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hakladar, Sundeep" userId="y1/WltXEm5nSVCP/gGh3/xtrA0BW/Ioykt6FkyYg4Hg=" providerId="None" clId="Web-{DDCD78FA-CBF4-4FF6-A4AD-97522FAC536D}"/>
    <pc:docChg chg="modSld">
      <pc:chgData name="Chakladar, Sundeep" userId="y1/WltXEm5nSVCP/gGh3/xtrA0BW/Ioykt6FkyYg4Hg=" providerId="None" clId="Web-{DDCD78FA-CBF4-4FF6-A4AD-97522FAC536D}" dt="2026-01-13T15:57:01.080" v="15" actId="14100"/>
      <pc:docMkLst>
        <pc:docMk/>
      </pc:docMkLst>
      <pc:sldChg chg="addSp delSp modSp">
        <pc:chgData name="Chakladar, Sundeep" userId="y1/WltXEm5nSVCP/gGh3/xtrA0BW/Ioykt6FkyYg4Hg=" providerId="None" clId="Web-{DDCD78FA-CBF4-4FF6-A4AD-97522FAC536D}" dt="2026-01-13T15:57:01.080" v="15" actId="14100"/>
        <pc:sldMkLst>
          <pc:docMk/>
          <pc:sldMk cId="109857222" sldId="256"/>
        </pc:sldMkLst>
        <pc:spChg chg="del">
          <ac:chgData name="Chakladar, Sundeep" userId="y1/WltXEm5nSVCP/gGh3/xtrA0BW/Ioykt6FkyYg4Hg=" providerId="None" clId="Web-{DDCD78FA-CBF4-4FF6-A4AD-97522FAC536D}" dt="2026-01-13T15:56:04.954" v="0"/>
          <ac:spMkLst>
            <pc:docMk/>
            <pc:sldMk cId="109857222" sldId="256"/>
            <ac:spMk id="2" creationId="{00000000-0000-0000-0000-000000000000}"/>
          </ac:spMkLst>
        </pc:spChg>
        <pc:spChg chg="del">
          <ac:chgData name="Chakladar, Sundeep" userId="y1/WltXEm5nSVCP/gGh3/xtrA0BW/Ioykt6FkyYg4Hg=" providerId="None" clId="Web-{DDCD78FA-CBF4-4FF6-A4AD-97522FAC536D}" dt="2026-01-13T15:56:06.204" v="1"/>
          <ac:spMkLst>
            <pc:docMk/>
            <pc:sldMk cId="109857222" sldId="256"/>
            <ac:spMk id="3" creationId="{00000000-0000-0000-0000-000000000000}"/>
          </ac:spMkLst>
        </pc:spChg>
        <pc:spChg chg="add mod">
          <ac:chgData name="Chakladar, Sundeep" userId="y1/WltXEm5nSVCP/gGh3/xtrA0BW/Ioykt6FkyYg4Hg=" providerId="None" clId="Web-{DDCD78FA-CBF4-4FF6-A4AD-97522FAC536D}" dt="2026-01-13T15:57:01.080" v="15" actId="14100"/>
          <ac:spMkLst>
            <pc:docMk/>
            <pc:sldMk cId="109857222" sldId="256"/>
            <ac:spMk id="6" creationId="{FB8D5034-DDE5-A59D-AD4A-7A1FF889245F}"/>
          </ac:spMkLst>
        </pc:spChg>
        <pc:picChg chg="add mod">
          <ac:chgData name="Chakladar, Sundeep" userId="y1/WltXEm5nSVCP/gGh3/xtrA0BW/Ioykt6FkyYg4Hg=" providerId="None" clId="Web-{DDCD78FA-CBF4-4FF6-A4AD-97522FAC536D}" dt="2026-01-13T15:56:24.564" v="5" actId="1076"/>
          <ac:picMkLst>
            <pc:docMk/>
            <pc:sldMk cId="109857222" sldId="256"/>
            <ac:picMk id="4" creationId="{6222F58C-348C-B7EA-B03F-6B43F6E93A89}"/>
          </ac:picMkLst>
        </pc:picChg>
        <pc:picChg chg="add mod">
          <ac:chgData name="Chakladar, Sundeep" userId="y1/WltXEm5nSVCP/gGh3/xtrA0BW/Ioykt6FkyYg4Hg=" providerId="None" clId="Web-{DDCD78FA-CBF4-4FF6-A4AD-97522FAC536D}" dt="2026-01-13T15:56:40.783" v="8" actId="14100"/>
          <ac:picMkLst>
            <pc:docMk/>
            <pc:sldMk cId="109857222" sldId="256"/>
            <ac:picMk id="5" creationId="{D669D333-A4AE-F23F-8C0C-E27B0C673615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5387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29054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94456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91384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524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/13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0920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/13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1723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/13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03125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/13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3889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/13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1841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/13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9582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46CE7D5-CF57-46EF-B807-FDD0502418D4}" type="datetimeFigureOut">
              <a:rPr lang="en-US" smtClean="0"/>
              <a:t>1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9540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6222F58C-348C-B7EA-B03F-6B43F6E93A8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62025" y="266700"/>
            <a:ext cx="4800600" cy="4095750"/>
          </a:xfrm>
          <a:prstGeom prst="rect">
            <a:avLst/>
          </a:prstGeom>
        </p:spPr>
      </p:pic>
      <p:pic>
        <p:nvPicPr>
          <p:cNvPr id="5" name="Picture 4" descr="A graph of different colored lines&#10;&#10;AI-generated content may be incorrect.">
            <a:extLst>
              <a:ext uri="{FF2B5EF4-FFF2-40B4-BE49-F238E27FC236}">
                <a16:creationId xmlns:a16="http://schemas.microsoft.com/office/drawing/2014/main" id="{D669D333-A4AE-F23F-8C0C-E27B0C67361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00" y="285750"/>
            <a:ext cx="4800600" cy="409575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B8D5034-DDE5-A59D-AD4A-7A1FF889245F}"/>
              </a:ext>
            </a:extLst>
          </p:cNvPr>
          <p:cNvSpPr txBox="1"/>
          <p:nvPr/>
        </p:nvSpPr>
        <p:spPr>
          <a:xfrm>
            <a:off x="457200" y="4819650"/>
            <a:ext cx="10915650" cy="80021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b="1">
                <a:latin typeface="Arial"/>
                <a:ea typeface="Arial"/>
                <a:cs typeface="Arial"/>
              </a:rPr>
              <a:t>Supp. Figure 1:</a:t>
            </a:r>
            <a:r>
              <a:rPr lang="en-US">
                <a:latin typeface="Arial"/>
                <a:ea typeface="Arial"/>
                <a:cs typeface="Arial"/>
              </a:rPr>
              <a:t> Training and validation loss over successive epochs of each U-net model during training.</a:t>
            </a:r>
            <a:endParaRPr lang="en-US" sz="2800"/>
          </a:p>
          <a:p>
            <a:pPr algn="ctr"/>
            <a:endParaRPr lang="en-US" sz="2800"/>
          </a:p>
        </p:txBody>
      </p:sp>
    </p:spTree>
    <p:extLst>
      <p:ext uri="{BB962C8B-B14F-4D97-AF65-F5344CB8AC3E}">
        <p14:creationId xmlns:p14="http://schemas.microsoft.com/office/powerpoint/2010/main" val="1098572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A0DE05DF-DE65-AA3B-8B21-B0C47D59314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40191" y="388378"/>
            <a:ext cx="6511618" cy="439009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9EDB69F2-C845-DB95-F5F7-F401A5354869}"/>
              </a:ext>
            </a:extLst>
          </p:cNvPr>
          <p:cNvSpPr txBox="1"/>
          <p:nvPr/>
        </p:nvSpPr>
        <p:spPr>
          <a:xfrm>
            <a:off x="457200" y="4819650"/>
            <a:ext cx="10915650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b="1" dirty="0"/>
              <a:t>Supplemental Figure 2:</a:t>
            </a:r>
            <a:r>
              <a:rPr lang="en-US" dirty="0"/>
              <a:t> Distribution of rodent ventricle volumes used for training models.</a:t>
            </a:r>
          </a:p>
        </p:txBody>
      </p:sp>
    </p:spTree>
    <p:extLst>
      <p:ext uri="{BB962C8B-B14F-4D97-AF65-F5344CB8AC3E}">
        <p14:creationId xmlns:p14="http://schemas.microsoft.com/office/powerpoint/2010/main" val="31469777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ptos" panose="020B000402020202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33</Words>
  <Application>Microsoft Office PowerPoint</Application>
  <PresentationFormat>Widescreen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Sundeep Chakladar</cp:lastModifiedBy>
  <cp:revision>12</cp:revision>
  <dcterms:created xsi:type="dcterms:W3CDTF">2026-01-13T15:55:57Z</dcterms:created>
  <dcterms:modified xsi:type="dcterms:W3CDTF">2026-01-13T16:03:32Z</dcterms:modified>
</cp:coreProperties>
</file>